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95" r:id="rId2"/>
  </p:sldIdLst>
  <p:sldSz cx="7589838" cy="1069816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m DeFalco" initials="TAD" lastIdx="9" clrIdx="0">
    <p:extLst/>
  </p:cmAuthor>
  <p:cmAuthor id="2" name="Christine" initials="C" lastIdx="3" clrIdx="1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FF9933"/>
    <a:srgbClr val="FF6600"/>
    <a:srgbClr val="000099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151" autoAdjust="0"/>
    <p:restoredTop sz="94660"/>
  </p:normalViewPr>
  <p:slideViewPr>
    <p:cSldViewPr snapToGrid="0">
      <p:cViewPr>
        <p:scale>
          <a:sx n="80" d="100"/>
          <a:sy n="80" d="100"/>
        </p:scale>
        <p:origin x="-1074" y="12"/>
      </p:cViewPr>
      <p:guideLst>
        <p:guide orient="horz" pos="3369"/>
        <p:guide pos="239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54AF71-6B0D-4268-8DE5-E904D13FBA94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3625" y="1143000"/>
            <a:ext cx="21907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B464A9-5B19-4301-BCA5-F20F7B3D91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1275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9238" y="1750834"/>
            <a:ext cx="6451362" cy="3724546"/>
          </a:xfrm>
        </p:spPr>
        <p:txBody>
          <a:bodyPr anchor="b"/>
          <a:lstStyle>
            <a:lvl1pPr algn="ctr">
              <a:defRPr sz="49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8730" y="5619013"/>
            <a:ext cx="5692379" cy="2582912"/>
          </a:xfrm>
        </p:spPr>
        <p:txBody>
          <a:bodyPr/>
          <a:lstStyle>
            <a:lvl1pPr marL="0" indent="0" algn="ctr">
              <a:buNone/>
              <a:defRPr sz="1992"/>
            </a:lvl1pPr>
            <a:lvl2pPr marL="379476" indent="0" algn="ctr">
              <a:buNone/>
              <a:defRPr sz="1660"/>
            </a:lvl2pPr>
            <a:lvl3pPr marL="758952" indent="0" algn="ctr">
              <a:buNone/>
              <a:defRPr sz="1494"/>
            </a:lvl3pPr>
            <a:lvl4pPr marL="1138428" indent="0" algn="ctr">
              <a:buNone/>
              <a:defRPr sz="1328"/>
            </a:lvl4pPr>
            <a:lvl5pPr marL="1517904" indent="0" algn="ctr">
              <a:buNone/>
              <a:defRPr sz="1328"/>
            </a:lvl5pPr>
            <a:lvl6pPr marL="1897380" indent="0" algn="ctr">
              <a:buNone/>
              <a:defRPr sz="1328"/>
            </a:lvl6pPr>
            <a:lvl7pPr marL="2276856" indent="0" algn="ctr">
              <a:buNone/>
              <a:defRPr sz="1328"/>
            </a:lvl7pPr>
            <a:lvl8pPr marL="2656332" indent="0" algn="ctr">
              <a:buNone/>
              <a:defRPr sz="1328"/>
            </a:lvl8pPr>
            <a:lvl9pPr marL="3035808" indent="0" algn="ctr">
              <a:buNone/>
              <a:defRPr sz="132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83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5675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31478" y="569578"/>
            <a:ext cx="1636559" cy="906619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21802" y="569578"/>
            <a:ext cx="4814803" cy="906619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221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268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7849" y="2667115"/>
            <a:ext cx="6546235" cy="4450138"/>
          </a:xfrm>
        </p:spPr>
        <p:txBody>
          <a:bodyPr anchor="b"/>
          <a:lstStyle>
            <a:lvl1pPr>
              <a:defRPr sz="49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7849" y="7159353"/>
            <a:ext cx="6546235" cy="2340222"/>
          </a:xfrm>
        </p:spPr>
        <p:txBody>
          <a:bodyPr/>
          <a:lstStyle>
            <a:lvl1pPr marL="0" indent="0">
              <a:buNone/>
              <a:defRPr sz="1992">
                <a:solidFill>
                  <a:schemeClr val="tx1"/>
                </a:solidFill>
              </a:defRPr>
            </a:lvl1pPr>
            <a:lvl2pPr marL="379476" indent="0">
              <a:buNone/>
              <a:defRPr sz="1660">
                <a:solidFill>
                  <a:schemeClr val="tx1">
                    <a:tint val="75000"/>
                  </a:schemeClr>
                </a:solidFill>
              </a:defRPr>
            </a:lvl2pPr>
            <a:lvl3pPr marL="758952" indent="0">
              <a:buNone/>
              <a:defRPr sz="1494">
                <a:solidFill>
                  <a:schemeClr val="tx1">
                    <a:tint val="75000"/>
                  </a:schemeClr>
                </a:solidFill>
              </a:defRPr>
            </a:lvl3pPr>
            <a:lvl4pPr marL="1138428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4pPr>
            <a:lvl5pPr marL="1517904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5pPr>
            <a:lvl6pPr marL="1897380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6pPr>
            <a:lvl7pPr marL="2276856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7pPr>
            <a:lvl8pPr marL="2656332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8pPr>
            <a:lvl9pPr marL="3035808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814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21801" y="2847891"/>
            <a:ext cx="3225681" cy="678788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42356" y="2847891"/>
            <a:ext cx="3225681" cy="678788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5907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790" y="569580"/>
            <a:ext cx="6546235" cy="20678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2791" y="2622536"/>
            <a:ext cx="3210857" cy="1285265"/>
          </a:xfrm>
        </p:spPr>
        <p:txBody>
          <a:bodyPr anchor="b"/>
          <a:lstStyle>
            <a:lvl1pPr marL="0" indent="0">
              <a:buNone/>
              <a:defRPr sz="1992" b="1"/>
            </a:lvl1pPr>
            <a:lvl2pPr marL="379476" indent="0">
              <a:buNone/>
              <a:defRPr sz="1660" b="1"/>
            </a:lvl2pPr>
            <a:lvl3pPr marL="758952" indent="0">
              <a:buNone/>
              <a:defRPr sz="1494" b="1"/>
            </a:lvl3pPr>
            <a:lvl4pPr marL="1138428" indent="0">
              <a:buNone/>
              <a:defRPr sz="1328" b="1"/>
            </a:lvl4pPr>
            <a:lvl5pPr marL="1517904" indent="0">
              <a:buNone/>
              <a:defRPr sz="1328" b="1"/>
            </a:lvl5pPr>
            <a:lvl6pPr marL="1897380" indent="0">
              <a:buNone/>
              <a:defRPr sz="1328" b="1"/>
            </a:lvl6pPr>
            <a:lvl7pPr marL="2276856" indent="0">
              <a:buNone/>
              <a:defRPr sz="1328" b="1"/>
            </a:lvl7pPr>
            <a:lvl8pPr marL="2656332" indent="0">
              <a:buNone/>
              <a:defRPr sz="1328" b="1"/>
            </a:lvl8pPr>
            <a:lvl9pPr marL="3035808" indent="0">
              <a:buNone/>
              <a:defRPr sz="132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2791" y="3907801"/>
            <a:ext cx="3210857" cy="57477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42356" y="2622536"/>
            <a:ext cx="3226670" cy="1285265"/>
          </a:xfrm>
        </p:spPr>
        <p:txBody>
          <a:bodyPr anchor="b"/>
          <a:lstStyle>
            <a:lvl1pPr marL="0" indent="0">
              <a:buNone/>
              <a:defRPr sz="1992" b="1"/>
            </a:lvl1pPr>
            <a:lvl2pPr marL="379476" indent="0">
              <a:buNone/>
              <a:defRPr sz="1660" b="1"/>
            </a:lvl2pPr>
            <a:lvl3pPr marL="758952" indent="0">
              <a:buNone/>
              <a:defRPr sz="1494" b="1"/>
            </a:lvl3pPr>
            <a:lvl4pPr marL="1138428" indent="0">
              <a:buNone/>
              <a:defRPr sz="1328" b="1"/>
            </a:lvl4pPr>
            <a:lvl5pPr marL="1517904" indent="0">
              <a:buNone/>
              <a:defRPr sz="1328" b="1"/>
            </a:lvl5pPr>
            <a:lvl6pPr marL="1897380" indent="0">
              <a:buNone/>
              <a:defRPr sz="1328" b="1"/>
            </a:lvl6pPr>
            <a:lvl7pPr marL="2276856" indent="0">
              <a:buNone/>
              <a:defRPr sz="1328" b="1"/>
            </a:lvl7pPr>
            <a:lvl8pPr marL="2656332" indent="0">
              <a:buNone/>
              <a:defRPr sz="1328" b="1"/>
            </a:lvl8pPr>
            <a:lvl9pPr marL="3035808" indent="0">
              <a:buNone/>
              <a:defRPr sz="132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42356" y="3907801"/>
            <a:ext cx="3226670" cy="57477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227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515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634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790" y="713211"/>
            <a:ext cx="2447920" cy="2496238"/>
          </a:xfrm>
        </p:spPr>
        <p:txBody>
          <a:bodyPr anchor="b"/>
          <a:lstStyle>
            <a:lvl1pPr>
              <a:defRPr sz="265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26670" y="1540340"/>
            <a:ext cx="3842355" cy="7602630"/>
          </a:xfrm>
        </p:spPr>
        <p:txBody>
          <a:bodyPr/>
          <a:lstStyle>
            <a:lvl1pPr>
              <a:defRPr sz="2656"/>
            </a:lvl1pPr>
            <a:lvl2pPr>
              <a:defRPr sz="2324"/>
            </a:lvl2pPr>
            <a:lvl3pPr>
              <a:defRPr sz="1992"/>
            </a:lvl3pPr>
            <a:lvl4pPr>
              <a:defRPr sz="1660"/>
            </a:lvl4pPr>
            <a:lvl5pPr>
              <a:defRPr sz="1660"/>
            </a:lvl5pPr>
            <a:lvl6pPr>
              <a:defRPr sz="1660"/>
            </a:lvl6pPr>
            <a:lvl7pPr>
              <a:defRPr sz="1660"/>
            </a:lvl7pPr>
            <a:lvl8pPr>
              <a:defRPr sz="1660"/>
            </a:lvl8pPr>
            <a:lvl9pPr>
              <a:defRPr sz="16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2790" y="3209449"/>
            <a:ext cx="2447920" cy="5945901"/>
          </a:xfrm>
        </p:spPr>
        <p:txBody>
          <a:bodyPr/>
          <a:lstStyle>
            <a:lvl1pPr marL="0" indent="0">
              <a:buNone/>
              <a:defRPr sz="1328"/>
            </a:lvl1pPr>
            <a:lvl2pPr marL="379476" indent="0">
              <a:buNone/>
              <a:defRPr sz="1162"/>
            </a:lvl2pPr>
            <a:lvl3pPr marL="758952" indent="0">
              <a:buNone/>
              <a:defRPr sz="996"/>
            </a:lvl3pPr>
            <a:lvl4pPr marL="1138428" indent="0">
              <a:buNone/>
              <a:defRPr sz="830"/>
            </a:lvl4pPr>
            <a:lvl5pPr marL="1517904" indent="0">
              <a:buNone/>
              <a:defRPr sz="830"/>
            </a:lvl5pPr>
            <a:lvl6pPr marL="1897380" indent="0">
              <a:buNone/>
              <a:defRPr sz="830"/>
            </a:lvl6pPr>
            <a:lvl7pPr marL="2276856" indent="0">
              <a:buNone/>
              <a:defRPr sz="830"/>
            </a:lvl7pPr>
            <a:lvl8pPr marL="2656332" indent="0">
              <a:buNone/>
              <a:defRPr sz="830"/>
            </a:lvl8pPr>
            <a:lvl9pPr marL="3035808" indent="0">
              <a:buNone/>
              <a:defRPr sz="8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971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790" y="713211"/>
            <a:ext cx="2447920" cy="2496238"/>
          </a:xfrm>
        </p:spPr>
        <p:txBody>
          <a:bodyPr anchor="b"/>
          <a:lstStyle>
            <a:lvl1pPr>
              <a:defRPr sz="265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26670" y="1540340"/>
            <a:ext cx="3842355" cy="7602630"/>
          </a:xfrm>
        </p:spPr>
        <p:txBody>
          <a:bodyPr anchor="t"/>
          <a:lstStyle>
            <a:lvl1pPr marL="0" indent="0">
              <a:buNone/>
              <a:defRPr sz="2656"/>
            </a:lvl1pPr>
            <a:lvl2pPr marL="379476" indent="0">
              <a:buNone/>
              <a:defRPr sz="2324"/>
            </a:lvl2pPr>
            <a:lvl3pPr marL="758952" indent="0">
              <a:buNone/>
              <a:defRPr sz="1992"/>
            </a:lvl3pPr>
            <a:lvl4pPr marL="1138428" indent="0">
              <a:buNone/>
              <a:defRPr sz="1660"/>
            </a:lvl4pPr>
            <a:lvl5pPr marL="1517904" indent="0">
              <a:buNone/>
              <a:defRPr sz="1660"/>
            </a:lvl5pPr>
            <a:lvl6pPr marL="1897380" indent="0">
              <a:buNone/>
              <a:defRPr sz="1660"/>
            </a:lvl6pPr>
            <a:lvl7pPr marL="2276856" indent="0">
              <a:buNone/>
              <a:defRPr sz="1660"/>
            </a:lvl7pPr>
            <a:lvl8pPr marL="2656332" indent="0">
              <a:buNone/>
              <a:defRPr sz="1660"/>
            </a:lvl8pPr>
            <a:lvl9pPr marL="3035808" indent="0">
              <a:buNone/>
              <a:defRPr sz="16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2790" y="3209449"/>
            <a:ext cx="2447920" cy="5945901"/>
          </a:xfrm>
        </p:spPr>
        <p:txBody>
          <a:bodyPr/>
          <a:lstStyle>
            <a:lvl1pPr marL="0" indent="0">
              <a:buNone/>
              <a:defRPr sz="1328"/>
            </a:lvl1pPr>
            <a:lvl2pPr marL="379476" indent="0">
              <a:buNone/>
              <a:defRPr sz="1162"/>
            </a:lvl2pPr>
            <a:lvl3pPr marL="758952" indent="0">
              <a:buNone/>
              <a:defRPr sz="996"/>
            </a:lvl3pPr>
            <a:lvl4pPr marL="1138428" indent="0">
              <a:buNone/>
              <a:defRPr sz="830"/>
            </a:lvl4pPr>
            <a:lvl5pPr marL="1517904" indent="0">
              <a:buNone/>
              <a:defRPr sz="830"/>
            </a:lvl5pPr>
            <a:lvl6pPr marL="1897380" indent="0">
              <a:buNone/>
              <a:defRPr sz="830"/>
            </a:lvl6pPr>
            <a:lvl7pPr marL="2276856" indent="0">
              <a:buNone/>
              <a:defRPr sz="830"/>
            </a:lvl7pPr>
            <a:lvl8pPr marL="2656332" indent="0">
              <a:buNone/>
              <a:defRPr sz="830"/>
            </a:lvl8pPr>
            <a:lvl9pPr marL="3035808" indent="0">
              <a:buNone/>
              <a:defRPr sz="8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219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21802" y="569580"/>
            <a:ext cx="6546235" cy="20678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1802" y="2847891"/>
            <a:ext cx="6546235" cy="678788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21801" y="9915615"/>
            <a:ext cx="1707714" cy="5695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470210-E710-44EA-8DF9-5226E47B3D76}" type="datetimeFigureOut">
              <a:rPr lang="en-US" smtClean="0"/>
              <a:t>8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14134" y="9915615"/>
            <a:ext cx="2561570" cy="5695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60323" y="9915615"/>
            <a:ext cx="1707714" cy="5695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11070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8952" rtl="0" eaLnBrk="1" latinLnBrk="0" hangingPunct="1">
        <a:lnSpc>
          <a:spcPct val="90000"/>
        </a:lnSpc>
        <a:spcBef>
          <a:spcPct val="0"/>
        </a:spcBef>
        <a:buNone/>
        <a:defRPr sz="365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738" indent="-189738" algn="l" defTabSz="758952" rtl="0" eaLnBrk="1" latinLnBrk="0" hangingPunct="1">
        <a:lnSpc>
          <a:spcPct val="90000"/>
        </a:lnSpc>
        <a:spcBef>
          <a:spcPts val="830"/>
        </a:spcBef>
        <a:buFont typeface="Arial" panose="020B0604020202020204" pitchFamily="34" charset="0"/>
        <a:buChar char="•"/>
        <a:defRPr sz="2324" kern="1200">
          <a:solidFill>
            <a:schemeClr val="tx1"/>
          </a:solidFill>
          <a:latin typeface="+mn-lt"/>
          <a:ea typeface="+mn-ea"/>
          <a:cs typeface="+mn-cs"/>
        </a:defRPr>
      </a:lvl1pPr>
      <a:lvl2pPr marL="569214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992" kern="1200">
          <a:solidFill>
            <a:schemeClr val="tx1"/>
          </a:solidFill>
          <a:latin typeface="+mn-lt"/>
          <a:ea typeface="+mn-ea"/>
          <a:cs typeface="+mn-cs"/>
        </a:defRPr>
      </a:lvl2pPr>
      <a:lvl3pPr marL="948690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660" kern="1200">
          <a:solidFill>
            <a:schemeClr val="tx1"/>
          </a:solidFill>
          <a:latin typeface="+mn-lt"/>
          <a:ea typeface="+mn-ea"/>
          <a:cs typeface="+mn-cs"/>
        </a:defRPr>
      </a:lvl3pPr>
      <a:lvl4pPr marL="1328166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4pPr>
      <a:lvl5pPr marL="1707642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5pPr>
      <a:lvl6pPr marL="2087118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6pPr>
      <a:lvl7pPr marL="2466594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7pPr>
      <a:lvl8pPr marL="2846070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8pPr>
      <a:lvl9pPr marL="3225546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1pPr>
      <a:lvl2pPr marL="379476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2pPr>
      <a:lvl3pPr marL="758952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3pPr>
      <a:lvl4pPr marL="1138428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4pPr>
      <a:lvl5pPr marL="1517904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5pPr>
      <a:lvl6pPr marL="1897380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6pPr>
      <a:lvl7pPr marL="2276856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7pPr>
      <a:lvl8pPr marL="2656332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8pPr>
      <a:lvl9pPr marL="3035808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499"/>
          <a:stretch/>
        </p:blipFill>
        <p:spPr bwMode="auto">
          <a:xfrm>
            <a:off x="669263" y="825628"/>
            <a:ext cx="5419725" cy="23687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307804" y="3194376"/>
            <a:ext cx="1154483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1. TEV</a:t>
            </a:r>
            <a:endParaRPr lang="en-CA" sz="1200" dirty="0"/>
          </a:p>
          <a:p>
            <a:r>
              <a:rPr lang="en-CA" sz="1200" dirty="0" smtClean="0"/>
              <a:t>2. </a:t>
            </a:r>
            <a:r>
              <a:rPr lang="en-CA" sz="1200" dirty="0"/>
              <a:t>ERF8 </a:t>
            </a:r>
            <a:r>
              <a:rPr lang="en-CA" sz="1200" dirty="0" err="1"/>
              <a:t>wt</a:t>
            </a:r>
            <a:endParaRPr lang="en-CA" sz="1200" dirty="0"/>
          </a:p>
          <a:p>
            <a:r>
              <a:rPr lang="en-CA" sz="1200" dirty="0" smtClean="0"/>
              <a:t>3. ERF8 S103A</a:t>
            </a:r>
            <a:endParaRPr lang="en-CA" sz="1200" dirty="0"/>
          </a:p>
          <a:p>
            <a:r>
              <a:rPr lang="en-CA" sz="1200" dirty="0" smtClean="0"/>
              <a:t>4. </a:t>
            </a:r>
            <a:r>
              <a:rPr lang="en-CA" sz="1200" dirty="0"/>
              <a:t>ERF8 S103D</a:t>
            </a:r>
          </a:p>
          <a:p>
            <a:r>
              <a:rPr lang="pt-BR" sz="1200" dirty="0" smtClean="0"/>
              <a:t>5. </a:t>
            </a:r>
            <a:r>
              <a:rPr lang="pt-BR" sz="1200" dirty="0" smtClean="0"/>
              <a:t>ERF8 quad A </a:t>
            </a:r>
            <a:endParaRPr lang="pt-BR" sz="1200" dirty="0"/>
          </a:p>
          <a:p>
            <a:r>
              <a:rPr lang="en-CA" sz="1200" dirty="0" smtClean="0"/>
              <a:t>6</a:t>
            </a:r>
            <a:r>
              <a:rPr lang="en-CA" sz="1200" dirty="0" smtClean="0"/>
              <a:t>. </a:t>
            </a:r>
            <a:r>
              <a:rPr lang="en-CA" sz="1200" dirty="0"/>
              <a:t>ERF8 </a:t>
            </a:r>
            <a:r>
              <a:rPr lang="en-CA" sz="1200" dirty="0" smtClean="0"/>
              <a:t>quad </a:t>
            </a:r>
            <a:r>
              <a:rPr lang="en-CA" sz="1200" dirty="0" smtClean="0"/>
              <a:t>D</a:t>
            </a:r>
            <a:endParaRPr lang="en-CA" sz="1200" dirty="0"/>
          </a:p>
          <a:p>
            <a:r>
              <a:rPr lang="en-CA" sz="1200" dirty="0" smtClean="0"/>
              <a:t>7. GV2260</a:t>
            </a:r>
            <a:endParaRPr lang="en-CA" sz="1200" dirty="0"/>
          </a:p>
        </p:txBody>
      </p:sp>
      <p:pic>
        <p:nvPicPr>
          <p:cNvPr id="18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0" t="13592" r="10380" b="7069"/>
          <a:stretch/>
        </p:blipFill>
        <p:spPr bwMode="auto">
          <a:xfrm>
            <a:off x="2317690" y="6767031"/>
            <a:ext cx="2094823" cy="7274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2" r="2612" b="3568"/>
          <a:stretch/>
        </p:blipFill>
        <p:spPr bwMode="auto">
          <a:xfrm>
            <a:off x="2317691" y="6017471"/>
            <a:ext cx="2094822" cy="7009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TextBox 19"/>
          <p:cNvSpPr txBox="1"/>
          <p:nvPr/>
        </p:nvSpPr>
        <p:spPr>
          <a:xfrm rot="18900000">
            <a:off x="2382210" y="5684218"/>
            <a:ext cx="8628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RF8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C284DF1E-3F03-43D1-8B8B-FEF59657EB84}"/>
              </a:ext>
            </a:extLst>
          </p:cNvPr>
          <p:cNvSpPr txBox="1"/>
          <p:nvPr/>
        </p:nvSpPr>
        <p:spPr>
          <a:xfrm>
            <a:off x="1610170" y="6992240"/>
            <a:ext cx="10024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NbActin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DC9F8370-5E91-401B-AD1F-09E5D2A9DB03}"/>
              </a:ext>
            </a:extLst>
          </p:cNvPr>
          <p:cNvSpPr txBox="1"/>
          <p:nvPr/>
        </p:nvSpPr>
        <p:spPr>
          <a:xfrm>
            <a:off x="1610170" y="6205963"/>
            <a:ext cx="10024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tERF8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918250FD-AC3B-43E3-840A-195FFFFAE026}"/>
              </a:ext>
            </a:extLst>
          </p:cNvPr>
          <p:cNvSpPr txBox="1"/>
          <p:nvPr/>
        </p:nvSpPr>
        <p:spPr>
          <a:xfrm rot="18900000">
            <a:off x="3692267" y="5089294"/>
            <a:ext cx="19766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RF8 </a:t>
            </a:r>
            <a:r>
              <a:rPr lang="en-US" sz="1200" baseline="30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uad</a:t>
            </a:r>
            <a:r>
              <a:rPr lang="en-US" sz="1200" baseline="30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8900000">
            <a:off x="2966547" y="5090937"/>
            <a:ext cx="20951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RF8 </a:t>
            </a:r>
            <a:r>
              <a:rPr lang="en-US" sz="1200" baseline="30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uad</a:t>
            </a:r>
            <a:r>
              <a:rPr lang="en-US" sz="1200" baseline="30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182562" y="7848124"/>
            <a:ext cx="7259859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5. 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ransient expression of </a:t>
            </a:r>
            <a:r>
              <a:rPr lang="en-CA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ERF8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CA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variants in </a:t>
            </a:r>
            <a:r>
              <a:rPr lang="en-CA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. </a:t>
            </a:r>
            <a:r>
              <a:rPr lang="en-CA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nthamiana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grobacterium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arrying HA-tagg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RF8,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RF8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103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ERF8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103D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ERF8 </a:t>
            </a:r>
            <a:r>
              <a:rPr lang="pt-BR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quad</a:t>
            </a:r>
            <a:r>
              <a:rPr lang="pt-B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ERF8</a:t>
            </a:r>
            <a:r>
              <a:rPr lang="en-CA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CA" sz="1200" baseline="30000" smtClean="0">
                <a:latin typeface="Arial" panose="020B0604020202020204" pitchFamily="34" charset="0"/>
                <a:cs typeface="Arial" panose="020B0604020202020204" pitchFamily="34" charset="0"/>
              </a:rPr>
              <a:t>quad</a:t>
            </a:r>
            <a:r>
              <a:rPr lang="en-CA" sz="120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CA" sz="1200" baseline="3000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ere expressed in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N.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benthamian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8600" indent="-228600">
              <a:buAutoNum type="alphaUcParenBoth"/>
            </a:pP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estern Blot of leaf tissue 48h after infiltration using an </a:t>
            </a:r>
            <a:r>
              <a:rPr lang="el-G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HA antibody. </a:t>
            </a:r>
          </a:p>
          <a:p>
            <a:pPr marL="228600" indent="-228600">
              <a:buAutoNum type="alphaUcParenBoth"/>
            </a:pP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B) RT-PCR analysis of the same samples. </a:t>
            </a:r>
            <a:r>
              <a:rPr lang="en-CA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bActin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served as a loading control.</a:t>
            </a:r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04037" y="517851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dirty="0" smtClean="0"/>
              <a:t>A</a:t>
            </a:r>
            <a:endParaRPr lang="en-CA" sz="1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407575" y="5178643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dirty="0" smtClean="0"/>
              <a:t>B</a:t>
            </a:r>
            <a:endParaRPr lang="en-CA" sz="14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515740" y="619696"/>
            <a:ext cx="33236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Trial 1                                     Trial 2 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3041911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23</TotalTime>
  <Words>111</Words>
  <Application>Microsoft Office PowerPoint</Application>
  <PresentationFormat>Custom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e</dc:creator>
  <cp:lastModifiedBy>moeder</cp:lastModifiedBy>
  <cp:revision>315</cp:revision>
  <dcterms:created xsi:type="dcterms:W3CDTF">2016-09-27T17:34:00Z</dcterms:created>
  <dcterms:modified xsi:type="dcterms:W3CDTF">2018-08-22T14:25:31Z</dcterms:modified>
</cp:coreProperties>
</file>